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405"/>
  </p:normalViewPr>
  <p:slideViewPr>
    <p:cSldViewPr snapToGrid="0">
      <p:cViewPr varScale="1">
        <p:scale>
          <a:sx n="87" d="100"/>
          <a:sy n="87" d="100"/>
        </p:scale>
        <p:origin x="352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2573136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853939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260347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677605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312988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4201925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490175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477005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653951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35947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421979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B0B19-2A29-B94F-A62F-CA099984E46F}" type="datetimeFigureOut">
              <a:rPr lang="en-FR" smtClean="0"/>
              <a:t>18/11/2024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C557C-E581-834B-84CC-3FF4402CCE75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174585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DR NileRed Control1+2">
            <a:hlinkClick r:id="" action="ppaction://media"/>
            <a:extLst>
              <a:ext uri="{FF2B5EF4-FFF2-40B4-BE49-F238E27FC236}">
                <a16:creationId xmlns:a16="http://schemas.microsoft.com/office/drawing/2014/main" id="{E5D5F965-3339-2D3B-107D-E97FE6C003C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563138" y="4855158"/>
            <a:ext cx="2880000" cy="2880000"/>
          </a:xfrm>
          <a:prstGeom prst="rect">
            <a:avLst/>
          </a:prstGeom>
        </p:spPr>
      </p:pic>
      <p:pic>
        <p:nvPicPr>
          <p:cNvPr id="5" name="DR NileRed Amp1+2">
            <a:hlinkClick r:id="" action="ppaction://media"/>
            <a:extLst>
              <a:ext uri="{FF2B5EF4-FFF2-40B4-BE49-F238E27FC236}">
                <a16:creationId xmlns:a16="http://schemas.microsoft.com/office/drawing/2014/main" id="{44A67B7E-8B32-E4A5-739F-CD447A36B53B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3614223" y="4855158"/>
            <a:ext cx="2880000" cy="2880000"/>
          </a:xfrm>
          <a:prstGeom prst="rect">
            <a:avLst/>
          </a:prstGeom>
        </p:spPr>
      </p:pic>
      <p:sp>
        <p:nvSpPr>
          <p:cNvPr id="6" name="TextBox 27">
            <a:extLst>
              <a:ext uri="{FF2B5EF4-FFF2-40B4-BE49-F238E27FC236}">
                <a16:creationId xmlns:a16="http://schemas.microsoft.com/office/drawing/2014/main" id="{BE40B131-DB7D-BD36-C057-558BEA24C935}"/>
              </a:ext>
            </a:extLst>
          </p:cNvPr>
          <p:cNvSpPr txBox="1"/>
          <p:nvPr/>
        </p:nvSpPr>
        <p:spPr>
          <a:xfrm>
            <a:off x="601210" y="4787582"/>
            <a:ext cx="7354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Control</a:t>
            </a:r>
          </a:p>
        </p:txBody>
      </p:sp>
      <p:sp>
        <p:nvSpPr>
          <p:cNvPr id="7" name="TextBox 28">
            <a:extLst>
              <a:ext uri="{FF2B5EF4-FFF2-40B4-BE49-F238E27FC236}">
                <a16:creationId xmlns:a16="http://schemas.microsoft.com/office/drawing/2014/main" id="{737CDB01-5FB1-C56C-936D-A30CBCA7B7C6}"/>
              </a:ext>
            </a:extLst>
          </p:cNvPr>
          <p:cNvSpPr txBox="1"/>
          <p:nvPr/>
        </p:nvSpPr>
        <p:spPr>
          <a:xfrm>
            <a:off x="3666452" y="4841546"/>
            <a:ext cx="1522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Ampicillin 1µg/ml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3331F361-C5A0-DA42-4A8A-5FEEBE45C9AE}"/>
              </a:ext>
            </a:extLst>
          </p:cNvPr>
          <p:cNvGrpSpPr/>
          <p:nvPr/>
        </p:nvGrpSpPr>
        <p:grpSpPr>
          <a:xfrm>
            <a:off x="547122" y="1032048"/>
            <a:ext cx="3005705" cy="2713999"/>
            <a:chOff x="438917" y="3610261"/>
            <a:chExt cx="2392296" cy="2160122"/>
          </a:xfrm>
        </p:grpSpPr>
        <p:pic>
          <p:nvPicPr>
            <p:cNvPr id="9" name="cell division.mp4">
              <a:hlinkClick r:id="" action="ppaction://media"/>
              <a:extLst>
                <a:ext uri="{FF2B5EF4-FFF2-40B4-BE49-F238E27FC236}">
                  <a16:creationId xmlns:a16="http://schemas.microsoft.com/office/drawing/2014/main" id="{7A636BAC-ECEA-85F1-C85B-642CF04641C3}"/>
                </a:ext>
              </a:extLst>
            </p:cNvPr>
            <p:cNvPicPr>
              <a:picLocks noChangeAspect="1"/>
            </p:cNvPicPr>
            <p:nvPr>
              <a:videoFile r:link="rId6"/>
              <p:extLst>
                <p:ext uri="{DAA4B4D4-6D71-4841-9C94-3DE7FCFB9230}">
                  <p14:media xmlns:p14="http://schemas.microsoft.com/office/powerpoint/2010/main" r:embed="rId5"/>
                </p:ext>
              </p:extLst>
            </p:nvPr>
          </p:nvPicPr>
          <p:blipFill rotWithShape="1">
            <a:blip r:embed="rId10">
              <a:lum bright="-20000" contrast="20000"/>
            </a:blip>
            <a:srcRect l="40454" t="32089" r="40612" b="41480"/>
            <a:stretch/>
          </p:blipFill>
          <p:spPr>
            <a:xfrm>
              <a:off x="438917" y="3610261"/>
              <a:ext cx="2288840" cy="2160122"/>
            </a:xfrm>
            <a:prstGeom prst="rect">
              <a:avLst/>
            </a:prstGeom>
          </p:spPr>
        </p:pic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E1537D85-DAE3-765C-AEB4-6BA120DE5A46}"/>
                </a:ext>
              </a:extLst>
            </p:cNvPr>
            <p:cNvCxnSpPr>
              <a:cxnSpLocks/>
            </p:cNvCxnSpPr>
            <p:nvPr/>
          </p:nvCxnSpPr>
          <p:spPr>
            <a:xfrm>
              <a:off x="2365782" y="5640953"/>
              <a:ext cx="1872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26C5A20-DF01-72EA-84C2-FB7F88EFB8D6}"/>
                </a:ext>
              </a:extLst>
            </p:cNvPr>
            <p:cNvSpPr txBox="1"/>
            <p:nvPr/>
          </p:nvSpPr>
          <p:spPr>
            <a:xfrm>
              <a:off x="2217871" y="5394350"/>
              <a:ext cx="613342" cy="3351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R" sz="1200" dirty="0">
                  <a:solidFill>
                    <a:schemeClr val="bg1"/>
                  </a:solidFill>
                </a:rPr>
                <a:t>1 µm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A59BD0E9-D2F8-AB17-38E8-DFC2925322AB}"/>
              </a:ext>
            </a:extLst>
          </p:cNvPr>
          <p:cNvSpPr txBox="1"/>
          <p:nvPr/>
        </p:nvSpPr>
        <p:spPr>
          <a:xfrm>
            <a:off x="495946" y="542441"/>
            <a:ext cx="1007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FR" dirty="0"/>
              <a:t>SI video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08FD099-897D-CDD9-5BB6-2D750463C7B7}"/>
              </a:ext>
            </a:extLst>
          </p:cNvPr>
          <p:cNvSpPr txBox="1"/>
          <p:nvPr/>
        </p:nvSpPr>
        <p:spPr>
          <a:xfrm>
            <a:off x="495946" y="3815931"/>
            <a:ext cx="579727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1100" b="1" dirty="0"/>
              <a:t>Video 1 caption: </a:t>
            </a:r>
            <a:r>
              <a:rPr lang="en-FR" sz="1100" dirty="0"/>
              <a:t>Time-lapse video of dividing exponential phase wild-type </a:t>
            </a:r>
            <a:r>
              <a:rPr lang="en-FR" sz="1100" i="1" dirty="0"/>
              <a:t>D. radiodurans </a:t>
            </a:r>
            <a:r>
              <a:rPr lang="en-FR" sz="1100" dirty="0"/>
              <a:t>stained with Nile Red. The tilted bacteria (top right) allow to observe the ‘sliding door’ septation from a side-view as opposed to the more common top view, which is typically obtained when imaging </a:t>
            </a:r>
            <a:r>
              <a:rPr lang="en-FR" sz="1100" i="1" dirty="0"/>
              <a:t>D. radiodurans </a:t>
            </a:r>
            <a:r>
              <a:rPr lang="en-FR" sz="1100" dirty="0"/>
              <a:t>on agarose pads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74F657E-4D4A-0060-81D3-394C2DC434D4}"/>
              </a:ext>
            </a:extLst>
          </p:cNvPr>
          <p:cNvSpPr txBox="1"/>
          <p:nvPr/>
        </p:nvSpPr>
        <p:spPr>
          <a:xfrm>
            <a:off x="524205" y="7908319"/>
            <a:ext cx="579727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1100" b="1" dirty="0"/>
              <a:t>Video 2 &amp; 3 caption: </a:t>
            </a:r>
            <a:r>
              <a:rPr lang="en-FR" sz="1100" dirty="0"/>
              <a:t>3h time-lapse videos of dividing exponential phase wild-type </a:t>
            </a:r>
            <a:r>
              <a:rPr lang="en-FR" sz="1100" i="1" dirty="0"/>
              <a:t>D. radiodurans </a:t>
            </a:r>
            <a:r>
              <a:rPr lang="en-FR" sz="1100" dirty="0"/>
              <a:t>stained with Nile Red.  Left: untreated control bacteria. Right: bacteria grown in the presence of 1µg/mL ampicillin included in the TGY2X agarose pad. Ampicillin severely impairs septation but not cell growth leading to distorted cell morphology and eventually to bursting of the bacteria.</a:t>
            </a:r>
          </a:p>
        </p:txBody>
      </p:sp>
    </p:spTree>
    <p:extLst>
      <p:ext uri="{BB962C8B-B14F-4D97-AF65-F5344CB8AC3E}">
        <p14:creationId xmlns:p14="http://schemas.microsoft.com/office/powerpoint/2010/main" val="2243914775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37</Words>
  <Application>Microsoft Macintosh PowerPoint</Application>
  <PresentationFormat>A4 Paper (210x297 mm)</PresentationFormat>
  <Paragraphs>6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a Timmins</dc:creator>
  <cp:lastModifiedBy>Joanna Timmins</cp:lastModifiedBy>
  <cp:revision>1</cp:revision>
  <dcterms:created xsi:type="dcterms:W3CDTF">2024-11-18T17:26:13Z</dcterms:created>
  <dcterms:modified xsi:type="dcterms:W3CDTF">2024-11-18T17:27:08Z</dcterms:modified>
</cp:coreProperties>
</file>